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91" d="100"/>
          <a:sy n="91" d="100"/>
        </p:scale>
        <p:origin x="1498" y="69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3AD1E5-03B8-4054-B24C-FB6989C2AA65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9FA5CD-A1FB-4C0F-A657-3BE4D0572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46026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8FCE-C0AA-4B8C-8C08-8B15B2D0739B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CFC7-3CDC-4CED-B584-1261609482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5802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8FCE-C0AA-4B8C-8C08-8B15B2D0739B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CFC7-3CDC-4CED-B584-1261609482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4810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8FCE-C0AA-4B8C-8C08-8B15B2D0739B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CFC7-3CDC-4CED-B584-1261609482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0037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8FCE-C0AA-4B8C-8C08-8B15B2D0739B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CFC7-3CDC-4CED-B584-1261609482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7040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8FCE-C0AA-4B8C-8C08-8B15B2D0739B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CFC7-3CDC-4CED-B584-1261609482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3486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8FCE-C0AA-4B8C-8C08-8B15B2D0739B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CFC7-3CDC-4CED-B584-1261609482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5780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8FCE-C0AA-4B8C-8C08-8B15B2D0739B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CFC7-3CDC-4CED-B584-1261609482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9170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8FCE-C0AA-4B8C-8C08-8B15B2D0739B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CFC7-3CDC-4CED-B584-1261609482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5441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8FCE-C0AA-4B8C-8C08-8B15B2D0739B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CFC7-3CDC-4CED-B584-1261609482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8261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8FCE-C0AA-4B8C-8C08-8B15B2D0739B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CFC7-3CDC-4CED-B584-1261609482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1831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8FCE-C0AA-4B8C-8C08-8B15B2D0739B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7CFC7-3CDC-4CED-B584-1261609482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114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E18FCE-C0AA-4B8C-8C08-8B15B2D0739B}" type="datetimeFigureOut">
              <a:rPr lang="ko-KR" altLang="en-US" smtClean="0"/>
              <a:t>2018-04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B7CFC7-3CDC-4CED-B584-1261609482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0009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3296" y="102298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TIMES" pitchFamily="18" charset="0"/>
                <a:cs typeface="TIMES" pitchFamily="18" charset="0"/>
              </a:rPr>
              <a:t>A</a:t>
            </a:r>
            <a:endParaRPr lang="ko-KR" altLang="en-US" sz="1000" b="1" dirty="0">
              <a:latin typeface="TIMES" pitchFamily="18" charset="0"/>
              <a:cs typeface="TIMES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47303" y="3166846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TIMES" pitchFamily="18" charset="0"/>
                <a:cs typeface="TIMES" pitchFamily="18" charset="0"/>
              </a:rPr>
              <a:t>B</a:t>
            </a:r>
            <a:endParaRPr lang="ko-KR" altLang="en-US" sz="1000" b="1" dirty="0">
              <a:latin typeface="TIMES" pitchFamily="18" charset="0"/>
              <a:cs typeface="TIMES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43296" y="512699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TIMES" pitchFamily="18" charset="0"/>
                <a:cs typeface="TIMES" pitchFamily="18" charset="0"/>
              </a:rPr>
              <a:t>C</a:t>
            </a:r>
            <a:endParaRPr lang="ko-KR" altLang="en-US" sz="1000" b="1" dirty="0">
              <a:latin typeface="TIMES" pitchFamily="18" charset="0"/>
              <a:cs typeface="TIMES" pitchFamily="18" charset="0"/>
            </a:endParaRPr>
          </a:p>
        </p:txBody>
      </p:sp>
      <p:graphicFrame>
        <p:nvGraphicFramePr>
          <p:cNvPr id="10" name="표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4334478"/>
              </p:ext>
            </p:extLst>
          </p:nvPr>
        </p:nvGraphicFramePr>
        <p:xfrm>
          <a:off x="755576" y="4611908"/>
          <a:ext cx="7992888" cy="948168"/>
        </p:xfrm>
        <a:graphic>
          <a:graphicData uri="http://schemas.openxmlformats.org/drawingml/2006/table">
            <a:tbl>
              <a:tblPr/>
              <a:tblGrid>
                <a:gridCol w="19878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8784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98784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293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26331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바탕" panose="02030600000101010101" pitchFamily="18" charset="-127"/>
                          <a:cs typeface="Times New Roman" pitchFamily="18" charset="0"/>
                        </a:rPr>
                        <a:t>Plant</a:t>
                      </a:r>
                    </a:p>
                  </a:txBody>
                  <a:tcPr marL="64770" marR="64770" marT="17905" marB="17905" anchor="ctr" horzOverflow="overflow">
                    <a:lnL>
                      <a:noFill/>
                    </a:lnL>
                    <a:lnR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>
                      <a:lvl1pPr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바탕" panose="02030600000101010101" pitchFamily="18" charset="-127"/>
                          <a:cs typeface="Times New Roman" pitchFamily="18" charset="0"/>
                        </a:rPr>
                        <a:t>Compound</a:t>
                      </a:r>
                    </a:p>
                  </a:txBody>
                  <a:tcPr marL="64770" marR="64770" marT="17905" marB="17905" anchor="ctr" horzOverflow="overflow">
                    <a:lnL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>
                      <a:lvl1pPr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 panose="020B0503020000020004" pitchFamily="50" charset="-127"/>
                          <a:cs typeface="Times New Roman" pitchFamily="18" charset="0"/>
                        </a:rPr>
                        <a:t>RT (min)</a:t>
                      </a:r>
                      <a:endParaRPr kumimoji="0" lang="en-US" altLang="ko-KR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맑은 고딕" panose="020B0503020000020004" pitchFamily="50" charset="-127"/>
                        <a:cs typeface="Times New Roman" pitchFamily="18" charset="0"/>
                      </a:endParaRPr>
                    </a:p>
                  </a:txBody>
                  <a:tcPr marL="64770" marR="64770" marT="17905" marB="17905" anchor="ctr" horzOverflow="overflow">
                    <a:lnL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>
                      <a:lvl1pPr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 latinLnBrk="1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바탕" panose="02030600000101010101" pitchFamily="18" charset="-127"/>
                          <a:cs typeface="Times New Roman" pitchFamily="18" charset="0"/>
                        </a:rPr>
                        <a:t>Contents (mg/g)</a:t>
                      </a:r>
                    </a:p>
                  </a:txBody>
                  <a:tcPr marL="64770" marR="64770" marT="17905" marB="17905" anchor="ctr" horzOverflow="overflow">
                    <a:lnL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556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9999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6331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altLang="ko-KR" sz="1000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rea angelica</a:t>
                      </a:r>
                      <a:endParaRPr kumimoji="0" lang="en-US" altLang="ko-KR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맑은 고딕" panose="020B0503020000020004" pitchFamily="50" charset="-127"/>
                        <a:cs typeface="Times New Roman" pitchFamily="18" charset="0"/>
                      </a:endParaRPr>
                    </a:p>
                  </a:txBody>
                  <a:tcPr marL="64772" marR="64772" marT="17902" marB="17902" anchor="ctr" horzOverflow="overflow">
                    <a:lnL>
                      <a:noFill/>
                    </a:lnL>
                    <a:lnR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맑은 고딕" panose="020B0503020000020004" pitchFamily="50" charset="-127"/>
                          <a:cs typeface="Times New Roman" pitchFamily="18" charset="0"/>
                        </a:rPr>
                        <a:t>Decursin</a:t>
                      </a:r>
                      <a:endParaRPr kumimoji="0" lang="en-US" altLang="ko-KR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맑은 고딕" panose="020B0503020000020004" pitchFamily="50" charset="-127"/>
                        <a:cs typeface="Times New Roman" pitchFamily="18" charset="0"/>
                      </a:endParaRPr>
                    </a:p>
                  </a:txBody>
                  <a:tcPr marL="64772" marR="64772" marT="17902" marB="17902" anchor="ctr" horzOverflow="overflow">
                    <a:lnL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맑은 고딕" panose="020B0503020000020004" pitchFamily="50" charset="-127"/>
                          <a:cs typeface="Times New Roman" pitchFamily="18" charset="0"/>
                        </a:rPr>
                        <a:t>73.8</a:t>
                      </a:r>
                    </a:p>
                  </a:txBody>
                  <a:tcPr marL="64770" marR="64770" marT="17905" marB="17905" anchor="ctr" horzOverflow="overflow">
                    <a:lnL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맑은 고딕" panose="020B0503020000020004" pitchFamily="50" charset="-127"/>
                          <a:cs typeface="Times New Roman" pitchFamily="18" charset="0"/>
                        </a:rPr>
                        <a:t>12.04</a:t>
                      </a:r>
                    </a:p>
                  </a:txBody>
                  <a:tcPr marL="64770" marR="64770" marT="17905" marB="17905" anchor="ctr" horzOverflow="overflow">
                    <a:lnL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556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6331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altLang="ko-KR" sz="1000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nseng radix</a:t>
                      </a:r>
                      <a:endParaRPr kumimoji="0" lang="en-US" altLang="ko-KR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맑은 고딕" panose="020B0503020000020004" pitchFamily="50" charset="-127"/>
                        <a:cs typeface="Times New Roman" pitchFamily="18" charset="0"/>
                      </a:endParaRPr>
                    </a:p>
                  </a:txBody>
                  <a:tcPr marL="64772" marR="64772" marT="17902" marB="17902" anchor="ctr" horzOverflow="overflow">
                    <a:lnL>
                      <a:noFill/>
                    </a:lnL>
                    <a:lnR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insenoside</a:t>
                      </a:r>
                      <a:r>
                        <a:rPr kumimoji="0" lang="en-US" altLang="ko-K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Rb1</a:t>
                      </a:r>
                      <a:endParaRPr kumimoji="0" lang="en-US" altLang="ko-KR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맑은 고딕" panose="020B0503020000020004" pitchFamily="50" charset="-127"/>
                        <a:cs typeface="Times New Roman" pitchFamily="18" charset="0"/>
                      </a:endParaRPr>
                    </a:p>
                  </a:txBody>
                  <a:tcPr marL="64772" marR="64772" marT="17902" marB="17902" anchor="ctr" horzOverflow="overflow">
                    <a:lnL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맑은 고딕" panose="020B0503020000020004" pitchFamily="50" charset="-127"/>
                          <a:cs typeface="Times New Roman" pitchFamily="18" charset="0"/>
                        </a:rPr>
                        <a:t>47.9</a:t>
                      </a:r>
                    </a:p>
                  </a:txBody>
                  <a:tcPr marL="64770" marR="64770" marT="17905" marB="17905" anchor="ctr" horzOverflow="overflow">
                    <a:lnL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39</a:t>
                      </a:r>
                      <a:endParaRPr kumimoji="0" lang="en-US" altLang="ko-KR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맑은 고딕" panose="020B0503020000020004" pitchFamily="50" charset="-127"/>
                        <a:cs typeface="Times New Roman" pitchFamily="18" charset="0"/>
                      </a:endParaRPr>
                    </a:p>
                  </a:txBody>
                  <a:tcPr marL="64770" marR="64770" marT="17905" marB="17905" anchor="ctr" horzOverflow="overflow">
                    <a:lnL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556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6331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1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맑은 고딕" panose="020B0503020000020004" pitchFamily="50" charset="-127"/>
                          <a:cs typeface="Times New Roman" pitchFamily="18" charset="0"/>
                        </a:rPr>
                        <a:t>Moschus</a:t>
                      </a:r>
                      <a:endParaRPr kumimoji="0" lang="en-US" altLang="ko-KR" sz="1000" b="0" i="1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맑은 고딕" panose="020B0503020000020004" pitchFamily="50" charset="-127"/>
                        <a:cs typeface="Times New Roman" pitchFamily="18" charset="0"/>
                      </a:endParaRPr>
                    </a:p>
                  </a:txBody>
                  <a:tcPr marL="64772" marR="64772" marT="17902" marB="17902" anchor="ctr" horzOverflow="overflow">
                    <a:lnL>
                      <a:noFill/>
                    </a:lnL>
                    <a:lnR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L-</a:t>
                      </a:r>
                      <a:r>
                        <a:rPr kumimoji="0" lang="en-US" altLang="ko-KR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muscon</a:t>
                      </a:r>
                      <a:endParaRPr kumimoji="0" lang="en-US" altLang="ko-KR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맑은 고딕" panose="020B0503020000020004" pitchFamily="50" charset="-127"/>
                        <a:cs typeface="Times New Roman" pitchFamily="18" charset="0"/>
                      </a:endParaRPr>
                    </a:p>
                  </a:txBody>
                  <a:tcPr marL="64772" marR="64772" marT="17902" marB="17902" anchor="ctr" horzOverflow="overflow">
                    <a:lnL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맑은 고딕" panose="020B0503020000020004" pitchFamily="50" charset="-127"/>
                          <a:cs typeface="Times New Roman" pitchFamily="18" charset="0"/>
                        </a:rPr>
                        <a:t>18.3</a:t>
                      </a:r>
                    </a:p>
                  </a:txBody>
                  <a:tcPr marL="64770" marR="64770" marT="17905" marB="17905" anchor="ctr" horzOverflow="overflow">
                    <a:lnL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맑은 고딕" panose="020B0503020000020004" pitchFamily="50" charset="-127"/>
                          <a:cs typeface="Times New Roman" pitchFamily="18" charset="0"/>
                        </a:rPr>
                        <a:t>0.23</a:t>
                      </a:r>
                    </a:p>
                  </a:txBody>
                  <a:tcPr marL="64770" marR="64770" marT="17905" marB="17905" anchor="ctr" horzOverflow="overflow">
                    <a:lnL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556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556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600" y="44624"/>
            <a:ext cx="8431213" cy="42306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7" name="직사각형 236"/>
          <p:cNvSpPr/>
          <p:nvPr/>
        </p:nvSpPr>
        <p:spPr>
          <a:xfrm>
            <a:off x="143296" y="5805264"/>
            <a:ext cx="8766559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100" b="1" dirty="0" smtClean="0">
                <a:latin typeface="TIMES" pitchFamily="18" charset="0"/>
                <a:cs typeface="TIMES" pitchFamily="18" charset="0"/>
              </a:rPr>
              <a:t>Supplementary figure 1. </a:t>
            </a:r>
            <a:r>
              <a:rPr lang="en-US" altLang="ko-KR" sz="1100" b="1" dirty="0">
                <a:latin typeface="TIMES" pitchFamily="18" charset="0"/>
                <a:cs typeface="TIMES" pitchFamily="18" charset="0"/>
              </a:rPr>
              <a:t>Fingerprint of </a:t>
            </a:r>
            <a:r>
              <a:rPr lang="en-US" altLang="ko-KR" sz="1100" b="1" i="1" dirty="0" err="1" smtClean="0">
                <a:latin typeface="TIMES" pitchFamily="18" charset="0"/>
                <a:cs typeface="TIMES" pitchFamily="18" charset="0"/>
              </a:rPr>
              <a:t>Gongjin-dan</a:t>
            </a:r>
            <a:r>
              <a:rPr lang="en-US" altLang="ko-KR" sz="1100" b="1" dirty="0" smtClean="0">
                <a:latin typeface="TIMES" pitchFamily="18" charset="0"/>
                <a:cs typeface="TIMES" pitchFamily="18" charset="0"/>
              </a:rPr>
              <a:t> (GJD). </a:t>
            </a:r>
            <a:r>
              <a:rPr lang="en-US" altLang="ko-KR" sz="1100" dirty="0" smtClean="0">
                <a:latin typeface="TIMES" pitchFamily="18" charset="0"/>
                <a:cs typeface="TIMES" pitchFamily="18" charset="0"/>
              </a:rPr>
              <a:t>GJD </a:t>
            </a:r>
            <a:r>
              <a:rPr lang="en-US" altLang="ko-KR" sz="1100" dirty="0">
                <a:latin typeface="TIMES" pitchFamily="18" charset="0"/>
                <a:cs typeface="TIMES" pitchFamily="18" charset="0"/>
              </a:rPr>
              <a:t>and its reference compounds were subjected to HPLC analysis. Histograms of </a:t>
            </a:r>
            <a:r>
              <a:rPr lang="en-US" altLang="ko-KR" sz="1100" dirty="0" smtClean="0">
                <a:latin typeface="TIMES" pitchFamily="18" charset="0"/>
                <a:cs typeface="TIMES" pitchFamily="18" charset="0"/>
              </a:rPr>
              <a:t>GJD </a:t>
            </a:r>
            <a:r>
              <a:rPr lang="en-US" altLang="ko-KR" sz="1100" dirty="0">
                <a:latin typeface="TIMES" pitchFamily="18" charset="0"/>
                <a:cs typeface="TIMES" pitchFamily="18" charset="0"/>
              </a:rPr>
              <a:t>(</a:t>
            </a:r>
            <a:r>
              <a:rPr lang="en-US" altLang="ko-KR" sz="1100" dirty="0" smtClean="0">
                <a:latin typeface="TIMES" pitchFamily="18" charset="0"/>
                <a:cs typeface="TIMES" pitchFamily="18" charset="0"/>
              </a:rPr>
              <a:t>A) and its reference </a:t>
            </a:r>
            <a:r>
              <a:rPr lang="en-US" altLang="ko-KR" sz="1100" dirty="0">
                <a:latin typeface="TIMES" pitchFamily="18" charset="0"/>
                <a:cs typeface="TIMES" pitchFamily="18" charset="0"/>
              </a:rPr>
              <a:t>compounds (B</a:t>
            </a:r>
            <a:r>
              <a:rPr lang="en-US" altLang="ko-KR" sz="1100" dirty="0" smtClean="0">
                <a:latin typeface="TIMES" pitchFamily="18" charset="0"/>
                <a:cs typeface="TIMES" pitchFamily="18" charset="0"/>
              </a:rPr>
              <a:t>), </a:t>
            </a:r>
            <a:r>
              <a:rPr lang="en-US" altLang="ko-KR" sz="1100" dirty="0">
                <a:latin typeface="TIMES" pitchFamily="18" charset="0"/>
                <a:cs typeface="TIMES" pitchFamily="18" charset="0"/>
              </a:rPr>
              <a:t>and the quantitative </a:t>
            </a:r>
            <a:r>
              <a:rPr lang="en-US" altLang="ko-KR" sz="1100" dirty="0" smtClean="0">
                <a:latin typeface="TIMES" pitchFamily="18" charset="0"/>
                <a:cs typeface="TIMES" pitchFamily="18" charset="0"/>
              </a:rPr>
              <a:t>analyses </a:t>
            </a:r>
            <a:r>
              <a:rPr lang="en-US" altLang="ko-KR" sz="1100" dirty="0">
                <a:latin typeface="TIMES" pitchFamily="18" charset="0"/>
                <a:cs typeface="TIMES" pitchFamily="18" charset="0"/>
              </a:rPr>
              <a:t>of </a:t>
            </a:r>
            <a:r>
              <a:rPr lang="en-US" altLang="ko-KR" sz="1100" dirty="0" smtClean="0">
                <a:latin typeface="TIMES" pitchFamily="18" charset="0"/>
                <a:cs typeface="TIMES" pitchFamily="18" charset="0"/>
              </a:rPr>
              <a:t>GJD (C) </a:t>
            </a:r>
            <a:r>
              <a:rPr lang="en-US" altLang="ko-KR" sz="1100" dirty="0">
                <a:latin typeface="TIMES" pitchFamily="18" charset="0"/>
                <a:cs typeface="TIMES" pitchFamily="18" charset="0"/>
              </a:rPr>
              <a:t>are presented. </a:t>
            </a:r>
            <a:r>
              <a:rPr lang="en-US" altLang="ko-KR" sz="1100" dirty="0" smtClean="0">
                <a:latin typeface="TIMES" pitchFamily="18" charset="0"/>
                <a:cs typeface="TIMES" pitchFamily="18" charset="0"/>
              </a:rPr>
              <a:t>These data were </a:t>
            </a:r>
            <a:r>
              <a:rPr lang="en-US" altLang="ko-KR" sz="1100" dirty="0">
                <a:latin typeface="TIMES" pitchFamily="18" charset="0"/>
                <a:cs typeface="TIMES" pitchFamily="18" charset="0"/>
              </a:rPr>
              <a:t>produced by </a:t>
            </a:r>
            <a:r>
              <a:rPr lang="en-US" altLang="ko-KR" sz="1100" dirty="0" err="1">
                <a:latin typeface="TIMES" pitchFamily="18" charset="0"/>
                <a:cs typeface="TIMES" pitchFamily="18" charset="0"/>
              </a:rPr>
              <a:t>Kyoung</a:t>
            </a:r>
            <a:r>
              <a:rPr lang="en-US" altLang="ko-KR" sz="1100" dirty="0">
                <a:latin typeface="TIMES" pitchFamily="18" charset="0"/>
                <a:cs typeface="TIMES" pitchFamily="18" charset="0"/>
              </a:rPr>
              <a:t>-Bang </a:t>
            </a:r>
            <a:r>
              <a:rPr lang="en-US" altLang="ko-KR" sz="1100" dirty="0" smtClean="0">
                <a:latin typeface="TIMES" pitchFamily="18" charset="0"/>
                <a:cs typeface="TIMES" pitchFamily="18" charset="0"/>
              </a:rPr>
              <a:t>Pharmaceutical </a:t>
            </a:r>
            <a:r>
              <a:rPr lang="en-US" altLang="ko-KR" sz="1100" dirty="0">
                <a:latin typeface="TIMES" pitchFamily="18" charset="0"/>
                <a:cs typeface="TIMES" pitchFamily="18" charset="0"/>
              </a:rPr>
              <a:t>Co. Ltd </a:t>
            </a:r>
            <a:r>
              <a:rPr lang="en-US" altLang="ko-KR" sz="1100" dirty="0" smtClean="0">
                <a:latin typeface="TIMES" pitchFamily="18" charset="0"/>
                <a:cs typeface="TIMES" pitchFamily="18" charset="0"/>
              </a:rPr>
              <a:t>for the submission to the Ministry of </a:t>
            </a:r>
            <a:r>
              <a:rPr lang="en-US" altLang="ko-KR" sz="1100" dirty="0">
                <a:latin typeface="TIMES" pitchFamily="18" charset="0"/>
                <a:cs typeface="TIMES" pitchFamily="18" charset="0"/>
              </a:rPr>
              <a:t>Food and Drug </a:t>
            </a:r>
            <a:r>
              <a:rPr lang="en-US" altLang="ko-KR" sz="1100" dirty="0" smtClean="0">
                <a:latin typeface="TIMES" pitchFamily="18" charset="0"/>
                <a:cs typeface="TIMES" pitchFamily="18" charset="0"/>
              </a:rPr>
              <a:t>Safety.</a:t>
            </a:r>
            <a:endParaRPr lang="ko-KR" altLang="en-US" sz="1100" dirty="0">
              <a:latin typeface="TIMES" pitchFamily="18" charset="0"/>
              <a:cs typeface="TIMES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3918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</TotalTime>
  <Words>96</Words>
  <Application>Microsoft Office PowerPoint</Application>
  <PresentationFormat>화면 슬라이드 쇼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바탕</vt:lpstr>
      <vt:lpstr>Arial</vt:lpstr>
      <vt:lpstr>TIMES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Windows 사용자</cp:lastModifiedBy>
  <cp:revision>31</cp:revision>
  <dcterms:created xsi:type="dcterms:W3CDTF">2018-03-29T06:27:05Z</dcterms:created>
  <dcterms:modified xsi:type="dcterms:W3CDTF">2018-04-08T04:00:36Z</dcterms:modified>
</cp:coreProperties>
</file>